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png" ContentType="image/png"/>
  <Override PartName="/ppt/media/image3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924CBA-ADCD-4C7E-A277-DDF0BF3F11E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8118E7-2385-4A76-BD45-A083D8411F2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9DED1CE-43BF-4E89-B75B-40F1BB70B4C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5DE7C3-A59A-4B64-8366-C023175D29A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E8CC81-C6F4-4927-AA80-CA1B4944218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812935-1B4D-4AD8-8955-B0283D4C059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A57AF1-AFE1-45FE-822C-7913BEF3D22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8422B8-88DA-48FE-927B-1706DE25E49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7DB813-7DA4-4EA1-8E75-54F3F7ACE9A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5BC1E4-5798-4ECB-8DD0-B1AA38FAA17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5BBF12-0490-4E8E-BF27-267D69E9655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E6675B-7F2D-45E6-A904-A5D90E61163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18C99F6-B825-4300-B818-5E74A1096926}" type="slidenum">
              <a:rPr b="0" lang="it-IT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3.pn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CasellaDiTesto 4"/>
          <p:cNvSpPr/>
          <p:nvPr/>
        </p:nvSpPr>
        <p:spPr>
          <a:xfrm>
            <a:off x="2899080" y="388800"/>
            <a:ext cx="234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Calibri"/>
                <a:ea typeface="Arial"/>
              </a:rPr>
              <a:t>L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CasellaDiTesto 5"/>
          <p:cNvSpPr/>
          <p:nvPr/>
        </p:nvSpPr>
        <p:spPr>
          <a:xfrm>
            <a:off x="1655640" y="262080"/>
            <a:ext cx="185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CasellaDiTesto 6"/>
          <p:cNvSpPr/>
          <p:nvPr/>
        </p:nvSpPr>
        <p:spPr>
          <a:xfrm>
            <a:off x="535680" y="395280"/>
            <a:ext cx="363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Calibri"/>
                <a:ea typeface="Arial"/>
              </a:rPr>
              <a:t>Ctrl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CasellaDiTesto 7"/>
          <p:cNvSpPr/>
          <p:nvPr/>
        </p:nvSpPr>
        <p:spPr>
          <a:xfrm>
            <a:off x="79200" y="393840"/>
            <a:ext cx="289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Calibri"/>
                <a:ea typeface="Arial"/>
              </a:rPr>
              <a:t>Pt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CasellaDiTesto 8"/>
          <p:cNvSpPr/>
          <p:nvPr/>
        </p:nvSpPr>
        <p:spPr>
          <a:xfrm>
            <a:off x="1045800" y="393840"/>
            <a:ext cx="249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Calibri"/>
                <a:ea typeface="Arial"/>
              </a:rPr>
              <a:t>B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6" name="Immagine 1" descr=""/>
          <p:cNvPicPr/>
          <p:nvPr/>
        </p:nvPicPr>
        <p:blipFill>
          <a:blip r:embed="rId1"/>
          <a:srcRect l="25232" t="36901" r="45241" b="40479"/>
          <a:stretch/>
        </p:blipFill>
        <p:spPr>
          <a:xfrm>
            <a:off x="34920" y="630360"/>
            <a:ext cx="3241800" cy="1985760"/>
          </a:xfrm>
          <a:prstGeom prst="rect">
            <a:avLst/>
          </a:prstGeom>
          <a:ln w="0">
            <a:noFill/>
          </a:ln>
        </p:spPr>
      </p:pic>
      <p:sp>
        <p:nvSpPr>
          <p:cNvPr id="47" name="CasellaDiTesto 6"/>
          <p:cNvSpPr/>
          <p:nvPr/>
        </p:nvSpPr>
        <p:spPr>
          <a:xfrm>
            <a:off x="1903320" y="396720"/>
            <a:ext cx="363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Calibri"/>
                <a:ea typeface="Arial"/>
              </a:rPr>
              <a:t>Ctrl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CasellaDiTesto 7"/>
          <p:cNvSpPr/>
          <p:nvPr/>
        </p:nvSpPr>
        <p:spPr>
          <a:xfrm>
            <a:off x="1446840" y="395280"/>
            <a:ext cx="289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Calibri"/>
                <a:ea typeface="Arial"/>
              </a:rPr>
              <a:t>Pt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CasellaDiTesto 8"/>
          <p:cNvSpPr/>
          <p:nvPr/>
        </p:nvSpPr>
        <p:spPr>
          <a:xfrm>
            <a:off x="2447640" y="395280"/>
            <a:ext cx="249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Calibri"/>
                <a:ea typeface="Arial"/>
              </a:rPr>
              <a:t>B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Parentesi graffa aperta 11"/>
          <p:cNvSpPr/>
          <p:nvPr/>
        </p:nvSpPr>
        <p:spPr>
          <a:xfrm rot="16200000">
            <a:off x="542880" y="2171880"/>
            <a:ext cx="287280" cy="1217520"/>
          </a:xfrm>
          <a:custGeom>
            <a:avLst/>
            <a:gdLst>
              <a:gd name="textAreaLeft" fmla="*/ 183600 w 287280"/>
              <a:gd name="textAreaRight" fmla="*/ 287640 w 287280"/>
              <a:gd name="textAreaTop" fmla="*/ 7200 h 1217520"/>
              <a:gd name="textAreaBottom" fmla="*/ 1210320 h 121752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213"/>
                  <a:pt x="10800" y="425"/>
                </a:cubicBezTo>
                <a:lnTo>
                  <a:pt x="10800" y="10375"/>
                </a:lnTo>
                <a:cubicBezTo>
                  <a:pt x="10800" y="10588"/>
                  <a:pt x="5400" y="10800"/>
                  <a:pt x="0" y="10800"/>
                </a:cubicBezTo>
                <a:cubicBezTo>
                  <a:pt x="5400" y="10800"/>
                  <a:pt x="10800" y="11013"/>
                  <a:pt x="10800" y="11225"/>
                </a:cubicBezTo>
                <a:lnTo>
                  <a:pt x="10800" y="21175"/>
                </a:lnTo>
                <a:cubicBezTo>
                  <a:pt x="10800" y="21388"/>
                  <a:pt x="16200" y="21600"/>
                  <a:pt x="21600" y="21600"/>
                </a:cubicBezTo>
              </a:path>
            </a:pathLst>
          </a:custGeom>
          <a:noFill/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CasellaDiTesto 13"/>
          <p:cNvSpPr/>
          <p:nvPr/>
        </p:nvSpPr>
        <p:spPr>
          <a:xfrm>
            <a:off x="363240" y="2905200"/>
            <a:ext cx="665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400" spc="-1" strike="noStrike">
                <a:solidFill>
                  <a:srgbClr val="000000"/>
                </a:solidFill>
                <a:latin typeface="Arial"/>
                <a:ea typeface="Arial"/>
              </a:rPr>
              <a:t>4F/9R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Parentesi graffa aperta 13"/>
          <p:cNvSpPr/>
          <p:nvPr/>
        </p:nvSpPr>
        <p:spPr>
          <a:xfrm rot="16200000">
            <a:off x="2011320" y="2198880"/>
            <a:ext cx="287280" cy="1163520"/>
          </a:xfrm>
          <a:custGeom>
            <a:avLst/>
            <a:gdLst>
              <a:gd name="textAreaLeft" fmla="*/ 183600 w 287280"/>
              <a:gd name="textAreaRight" fmla="*/ 287640 w 287280"/>
              <a:gd name="textAreaTop" fmla="*/ 7200 h 1163520"/>
              <a:gd name="textAreaBottom" fmla="*/ 1156320 h 116352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222"/>
                  <a:pt x="10800" y="444"/>
                </a:cubicBezTo>
                <a:lnTo>
                  <a:pt x="10800" y="10356"/>
                </a:lnTo>
                <a:cubicBezTo>
                  <a:pt x="10800" y="10578"/>
                  <a:pt x="5400" y="10800"/>
                  <a:pt x="0" y="10800"/>
                </a:cubicBezTo>
                <a:cubicBezTo>
                  <a:pt x="5400" y="10800"/>
                  <a:pt x="10800" y="11022"/>
                  <a:pt x="10800" y="11244"/>
                </a:cubicBezTo>
                <a:lnTo>
                  <a:pt x="10800" y="21156"/>
                </a:lnTo>
                <a:cubicBezTo>
                  <a:pt x="10800" y="21378"/>
                  <a:pt x="16200" y="21600"/>
                  <a:pt x="21600" y="21600"/>
                </a:cubicBezTo>
              </a:path>
            </a:pathLst>
          </a:custGeom>
          <a:noFill/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CasellaDiTesto 13"/>
          <p:cNvSpPr/>
          <p:nvPr/>
        </p:nvSpPr>
        <p:spPr>
          <a:xfrm>
            <a:off x="1724760" y="2905200"/>
            <a:ext cx="863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400" spc="-1" strike="noStrike">
                <a:solidFill>
                  <a:srgbClr val="000000"/>
                </a:solidFill>
                <a:latin typeface="Arial"/>
                <a:ea typeface="Arial"/>
              </a:rPr>
              <a:t>10F/15R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4" name="Immagine 15" descr=""/>
          <p:cNvPicPr/>
          <p:nvPr/>
        </p:nvPicPr>
        <p:blipFill>
          <a:blip r:embed="rId2"/>
          <a:srcRect l="47143" t="51194" r="39915" b="35716"/>
          <a:stretch/>
        </p:blipFill>
        <p:spPr>
          <a:xfrm>
            <a:off x="3497400" y="636480"/>
            <a:ext cx="1511280" cy="1224000"/>
          </a:xfrm>
          <a:prstGeom prst="rect">
            <a:avLst/>
          </a:prstGeom>
          <a:ln w="0">
            <a:noFill/>
          </a:ln>
        </p:spPr>
      </p:pic>
      <p:sp>
        <p:nvSpPr>
          <p:cNvPr id="55" name="CasellaDiTesto 7"/>
          <p:cNvSpPr/>
          <p:nvPr/>
        </p:nvSpPr>
        <p:spPr>
          <a:xfrm>
            <a:off x="44640" y="115920"/>
            <a:ext cx="578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  <a:ea typeface="Arial"/>
              </a:rPr>
              <a:t>KARS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CasellaDiTesto 4"/>
          <p:cNvSpPr/>
          <p:nvPr/>
        </p:nvSpPr>
        <p:spPr>
          <a:xfrm>
            <a:off x="4700160" y="412920"/>
            <a:ext cx="234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Calibri"/>
                <a:ea typeface="Arial"/>
              </a:rPr>
              <a:t>L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CasellaDiTesto 6"/>
          <p:cNvSpPr/>
          <p:nvPr/>
        </p:nvSpPr>
        <p:spPr>
          <a:xfrm>
            <a:off x="3920400" y="414360"/>
            <a:ext cx="363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Calibri"/>
                <a:ea typeface="Arial"/>
              </a:rPr>
              <a:t>Ctrl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CasellaDiTesto 7"/>
          <p:cNvSpPr/>
          <p:nvPr/>
        </p:nvSpPr>
        <p:spPr>
          <a:xfrm>
            <a:off x="3569400" y="412920"/>
            <a:ext cx="289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Calibri"/>
                <a:ea typeface="Arial"/>
              </a:rPr>
              <a:t>Pt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CasellaDiTesto 8"/>
          <p:cNvSpPr/>
          <p:nvPr/>
        </p:nvSpPr>
        <p:spPr>
          <a:xfrm>
            <a:off x="4323960" y="412920"/>
            <a:ext cx="249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Calibri"/>
                <a:ea typeface="Arial"/>
              </a:rPr>
              <a:t>B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CasellaDiTesto 7"/>
          <p:cNvSpPr/>
          <p:nvPr/>
        </p:nvSpPr>
        <p:spPr>
          <a:xfrm>
            <a:off x="3502080" y="122400"/>
            <a:ext cx="633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  <a:ea typeface="Arial"/>
              </a:rPr>
              <a:t>GAPDH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Rettangolo 25"/>
          <p:cNvSpPr/>
          <p:nvPr/>
        </p:nvSpPr>
        <p:spPr>
          <a:xfrm>
            <a:off x="5072040" y="-290520"/>
            <a:ext cx="4022640" cy="399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DNA analysis on muscle. The same amount of RNA (1.3mg/ul) was reverse-transcribed into cDNA using Transcriptor First Strand cDNA Synthesis kit (Roche); the housekeeping gene GAPDH was amplified to verify cDNA quality.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wo fragments of the KARS1 cDNA were amplified (with primers overlapping intron-exon boundaries), obtaining a single band that correspond to the heterozygous mutated transcript, as verified by Sanger sequencing, thus excluding mutated mRNA decay.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L: DNA size marker (100bp); Pt: patient; Ctrl: control; B: blank. From the electropherogram inspection, it is evident that the mutant and wildtype peaks are equally expressed in the traces (see arrows).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2" name="Immagine 2" descr=""/>
          <p:cNvPicPr/>
          <p:nvPr/>
        </p:nvPicPr>
        <p:blipFill>
          <a:blip r:embed="rId3"/>
          <a:srcRect l="12201" t="27601" r="50833" b="38803"/>
          <a:stretch/>
        </p:blipFill>
        <p:spPr>
          <a:xfrm>
            <a:off x="223920" y="4002120"/>
            <a:ext cx="4240080" cy="2163600"/>
          </a:xfrm>
          <a:prstGeom prst="rect">
            <a:avLst/>
          </a:prstGeom>
          <a:ln w="0">
            <a:noFill/>
          </a:ln>
        </p:spPr>
      </p:pic>
      <p:pic>
        <p:nvPicPr>
          <p:cNvPr id="63" name="Immagine 27" descr=""/>
          <p:cNvPicPr/>
          <p:nvPr/>
        </p:nvPicPr>
        <p:blipFill>
          <a:blip r:embed="rId4"/>
          <a:srcRect l="49102" t="27601" r="13776" b="38803"/>
          <a:stretch/>
        </p:blipFill>
        <p:spPr>
          <a:xfrm>
            <a:off x="4649760" y="4002120"/>
            <a:ext cx="4259160" cy="2163600"/>
          </a:xfrm>
          <a:prstGeom prst="rect">
            <a:avLst/>
          </a:prstGeom>
          <a:ln w="0">
            <a:noFill/>
          </a:ln>
        </p:spPr>
      </p:pic>
      <p:sp>
        <p:nvSpPr>
          <p:cNvPr id="64" name="Rettangolo 3"/>
          <p:cNvSpPr/>
          <p:nvPr/>
        </p:nvSpPr>
        <p:spPr>
          <a:xfrm>
            <a:off x="1042920" y="6165720"/>
            <a:ext cx="25243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400" spc="-1" strike="noStrike">
                <a:solidFill>
                  <a:srgbClr val="1d2228"/>
                </a:solidFill>
                <a:latin typeface="Arial"/>
                <a:ea typeface="Arial"/>
              </a:rPr>
              <a:t>c.815T&gt;G/p.[Phe272Cys]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Rettangolo 4"/>
          <p:cNvSpPr/>
          <p:nvPr/>
        </p:nvSpPr>
        <p:spPr>
          <a:xfrm>
            <a:off x="5724360" y="6134040"/>
            <a:ext cx="2651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400" spc="-1" strike="noStrike">
                <a:solidFill>
                  <a:srgbClr val="1d2228"/>
                </a:solidFill>
                <a:latin typeface="Arial"/>
                <a:ea typeface="Arial"/>
              </a:rPr>
              <a:t>c.1570T&gt;C/p.[Cys524Arg]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0-09-15T15:35:48Z</dcterms:created>
  <dc:creator>Peluso Francesca</dc:creator>
  <dc:description/>
  <dc:language>en-US</dc:language>
  <cp:lastModifiedBy>Francesca Peluso</cp:lastModifiedBy>
  <dcterms:modified xsi:type="dcterms:W3CDTF">2020-12-07T16:16:51Z</dcterms:modified>
  <cp:revision>12</cp:revision>
  <dc:subject/>
  <dc:title>Presentazione standard di PowerPoint</dc:title>
</cp:coreProperties>
</file>